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2" r:id="rId2"/>
    <p:sldId id="263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" name="作成者" initials="A" lastIdx="3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37" autoAdjust="0"/>
    <p:restoredTop sz="95292" autoAdjust="0"/>
  </p:normalViewPr>
  <p:slideViewPr>
    <p:cSldViewPr snapToGrid="0">
      <p:cViewPr varScale="1">
        <p:scale>
          <a:sx n="86" d="100"/>
          <a:sy n="86" d="100"/>
        </p:scale>
        <p:origin x="44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My%20Documments\&#25237;&#31295;&#35542;&#25991;\2024&#24180;&#25237;&#31295;&#35542;&#25991;\Food%20Sci%20&amp;%20%20Nutr%20(Kelp%20study)\Phylum%20grap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My%20Documments\&#25237;&#31295;&#35542;&#25991;\2024&#24180;&#25237;&#31295;&#35542;&#25991;\Food%20Sci%20&amp;%20%20Nutr%20(Kelp%20study)\Genus(Pre_Post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My%20Documments\&#25237;&#31295;&#35542;&#25991;\2024&#24180;&#25237;&#31295;&#35542;&#25991;\Food%20Sci%20&amp;%20%20Nutr%20(Kelp%20study)\Figur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My%20Documments\&#25237;&#31295;&#35542;&#25991;\2024&#24180;&#25237;&#31295;&#35542;&#25991;\Food%20Sci%20&amp;%20%20Nutr%20(Kelp%20study)\Figur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My%20Documments\&#25237;&#31295;&#35542;&#25991;\2024&#24180;&#25237;&#31295;&#35542;&#25991;\Food%20Sci%20&amp;%20%20Nutr%20(Kelp%20study)\Figur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My%20Documments\&#25237;&#31295;&#35542;&#25991;\2024&#24180;&#25237;&#31295;&#35542;&#25991;\Food%20Sci%20&amp;%20%20Nutr%20(Kelp%20study)\Figure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hylum</a:t>
            </a:r>
            <a:endParaRPr lang="ja-JP" altLang="en-US">
              <a:solidFill>
                <a:schemeClr val="tx1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 alt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Bacteroidot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C$2:$C$5</c:f>
              <c:numCache>
                <c:formatCode>General</c:formatCode>
                <c:ptCount val="4"/>
                <c:pt idx="0">
                  <c:v>54.010952380952368</c:v>
                </c:pt>
                <c:pt idx="1">
                  <c:v>53.490526315789474</c:v>
                </c:pt>
                <c:pt idx="2">
                  <c:v>28.215954965037422</c:v>
                </c:pt>
                <c:pt idx="3">
                  <c:v>28.7831014268271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2E-4027-BA6C-CD737F512CB7}"/>
            </c:ext>
          </c:extLst>
        </c:ser>
        <c:ser>
          <c:idx val="1"/>
          <c:order val="1"/>
          <c:tx>
            <c:strRef>
              <c:f>Sheet1!$D$1</c:f>
              <c:strCache>
                <c:ptCount val="1"/>
                <c:pt idx="0">
                  <c:v>Firmicut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D$2:$D$5</c:f>
              <c:numCache>
                <c:formatCode>General</c:formatCode>
                <c:ptCount val="4"/>
                <c:pt idx="0">
                  <c:v>34.577619047619045</c:v>
                </c:pt>
                <c:pt idx="1">
                  <c:v>37.193684210526328</c:v>
                </c:pt>
                <c:pt idx="2">
                  <c:v>61.117709104002643</c:v>
                </c:pt>
                <c:pt idx="3">
                  <c:v>61.055596649408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2E-4027-BA6C-CD737F512CB7}"/>
            </c:ext>
          </c:extLst>
        </c:ser>
        <c:ser>
          <c:idx val="2"/>
          <c:order val="2"/>
          <c:tx>
            <c:strRef>
              <c:f>Sheet1!$E$1</c:f>
              <c:strCache>
                <c:ptCount val="1"/>
                <c:pt idx="0">
                  <c:v>Fusobacteriot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E$2:$E$5</c:f>
              <c:numCache>
                <c:formatCode>General</c:formatCode>
                <c:ptCount val="4"/>
                <c:pt idx="0">
                  <c:v>1.6304761904761902</c:v>
                </c:pt>
                <c:pt idx="1">
                  <c:v>2.2321052631578948</c:v>
                </c:pt>
                <c:pt idx="2">
                  <c:v>0.15348986512336818</c:v>
                </c:pt>
                <c:pt idx="3">
                  <c:v>0.65116855661844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92E-4027-BA6C-CD737F512CB7}"/>
            </c:ext>
          </c:extLst>
        </c:ser>
        <c:ser>
          <c:idx val="3"/>
          <c:order val="3"/>
          <c:tx>
            <c:strRef>
              <c:f>Sheet1!$F$1</c:f>
              <c:strCache>
                <c:ptCount val="1"/>
                <c:pt idx="0">
                  <c:v>Proteobacteri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F$2:$F$5</c:f>
              <c:numCache>
                <c:formatCode>General</c:formatCode>
                <c:ptCount val="4"/>
                <c:pt idx="0">
                  <c:v>5.0076190476190474</c:v>
                </c:pt>
                <c:pt idx="1">
                  <c:v>4.4584210526315795</c:v>
                </c:pt>
                <c:pt idx="2">
                  <c:v>1.4176735747242382</c:v>
                </c:pt>
                <c:pt idx="3">
                  <c:v>2.09041539582742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92E-4027-BA6C-CD737F512CB7}"/>
            </c:ext>
          </c:extLst>
        </c:ser>
        <c:ser>
          <c:idx val="4"/>
          <c:order val="4"/>
          <c:tx>
            <c:strRef>
              <c:f>Sheet1!$G$1</c:f>
              <c:strCache>
                <c:ptCount val="1"/>
                <c:pt idx="0">
                  <c:v>Actinobacteriot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G$2:$G$5</c:f>
              <c:numCache>
                <c:formatCode>General</c:formatCode>
                <c:ptCount val="4"/>
                <c:pt idx="0">
                  <c:v>3.1228571428571428</c:v>
                </c:pt>
                <c:pt idx="1">
                  <c:v>2.034736842105263</c:v>
                </c:pt>
                <c:pt idx="2">
                  <c:v>7.9272556256444791</c:v>
                </c:pt>
                <c:pt idx="3">
                  <c:v>6.93666756851860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92E-4027-BA6C-CD737F512CB7}"/>
            </c:ext>
          </c:extLst>
        </c:ser>
        <c:ser>
          <c:idx val="5"/>
          <c:order val="5"/>
          <c:tx>
            <c:strRef>
              <c:f>Sheet1!$H$1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H$2:$H$5</c:f>
              <c:numCache>
                <c:formatCode>General</c:formatCode>
                <c:ptCount val="4"/>
                <c:pt idx="0">
                  <c:v>1.650476190476212</c:v>
                </c:pt>
                <c:pt idx="1">
                  <c:v>0.59052631578946091</c:v>
                </c:pt>
                <c:pt idx="2">
                  <c:v>1.1679168654678591</c:v>
                </c:pt>
                <c:pt idx="3">
                  <c:v>0.483050402800245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92E-4027-BA6C-CD737F512C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424303"/>
        <c:axId val="186410383"/>
      </c:barChart>
      <c:catAx>
        <c:axId val="1864243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defRPr>
            </a:pPr>
            <a:endParaRPr lang="ja-JP"/>
          </a:p>
        </c:txPr>
        <c:crossAx val="186410383"/>
        <c:crosses val="autoZero"/>
        <c:auto val="1"/>
        <c:lblAlgn val="ctr"/>
        <c:lblOffset val="100"/>
        <c:noMultiLvlLbl val="0"/>
      </c:catAx>
      <c:valAx>
        <c:axId val="18641038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undance</a:t>
                </a:r>
                <a:endPara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 alt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defRPr>
            </a:pPr>
            <a:endParaRPr lang="ja-JP"/>
          </a:p>
        </c:txPr>
        <c:crossAx val="186424303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Genus</a:t>
            </a:r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 alt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C$1</c:f>
              <c:strCache>
                <c:ptCount val="1"/>
                <c:pt idx="0">
                  <c:v>Bifidobacteriu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C$2:$C$5</c:f>
              <c:numCache>
                <c:formatCode>0.00</c:formatCode>
                <c:ptCount val="4"/>
                <c:pt idx="0">
                  <c:v>1.7353809575512773</c:v>
                </c:pt>
                <c:pt idx="1">
                  <c:v>1.8049888917431303</c:v>
                </c:pt>
                <c:pt idx="2">
                  <c:v>6.3993708057623744</c:v>
                </c:pt>
                <c:pt idx="3">
                  <c:v>6.05315437830786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CA-4FCA-AD67-978CEB3758B8}"/>
            </c:ext>
          </c:extLst>
        </c:ser>
        <c:ser>
          <c:idx val="1"/>
          <c:order val="1"/>
          <c:tx>
            <c:strRef>
              <c:f>Sheet1!$D$1</c:f>
              <c:strCache>
                <c:ptCount val="1"/>
                <c:pt idx="0">
                  <c:v>Collinsell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D$2:$D$5</c:f>
              <c:numCache>
                <c:formatCode>0.00</c:formatCode>
                <c:ptCount val="4"/>
                <c:pt idx="0">
                  <c:v>0.88334515807660452</c:v>
                </c:pt>
                <c:pt idx="1">
                  <c:v>0.66135232221056461</c:v>
                </c:pt>
                <c:pt idx="2">
                  <c:v>1.2543099393301644</c:v>
                </c:pt>
                <c:pt idx="3">
                  <c:v>0.956583840999908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8CA-4FCA-AD67-978CEB3758B8}"/>
            </c:ext>
          </c:extLst>
        </c:ser>
        <c:ser>
          <c:idx val="2"/>
          <c:order val="2"/>
          <c:tx>
            <c:strRef>
              <c:f>Sheet1!$E$1</c:f>
              <c:strCache>
                <c:ptCount val="1"/>
                <c:pt idx="0">
                  <c:v>Bacteroidales;__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E$2:$E$5</c:f>
              <c:numCache>
                <c:formatCode>0.00</c:formatCode>
                <c:ptCount val="4"/>
                <c:pt idx="0">
                  <c:v>0.62945979830591958</c:v>
                </c:pt>
                <c:pt idx="1">
                  <c:v>0.7564139648555448</c:v>
                </c:pt>
                <c:pt idx="2">
                  <c:v>0.11805011601831202</c:v>
                </c:pt>
                <c:pt idx="3">
                  <c:v>0.18302030741965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8CA-4FCA-AD67-978CEB3758B8}"/>
            </c:ext>
          </c:extLst>
        </c:ser>
        <c:ser>
          <c:idx val="3"/>
          <c:order val="3"/>
          <c:tx>
            <c:strRef>
              <c:f>Sheet1!$F$1</c:f>
              <c:strCache>
                <c:ptCount val="1"/>
                <c:pt idx="0">
                  <c:v>Bacteroide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F$2:$F$5</c:f>
              <c:numCache>
                <c:formatCode>0.00</c:formatCode>
                <c:ptCount val="4"/>
                <c:pt idx="0">
                  <c:v>33.318272766732662</c:v>
                </c:pt>
                <c:pt idx="1">
                  <c:v>41.476322636116002</c:v>
                </c:pt>
                <c:pt idx="2">
                  <c:v>16.465862834600596</c:v>
                </c:pt>
                <c:pt idx="3">
                  <c:v>21.6380850410872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8CA-4FCA-AD67-978CEB3758B8}"/>
            </c:ext>
          </c:extLst>
        </c:ser>
        <c:ser>
          <c:idx val="4"/>
          <c:order val="4"/>
          <c:tx>
            <c:strRef>
              <c:f>Sheet1!$G$1</c:f>
              <c:strCache>
                <c:ptCount val="1"/>
                <c:pt idx="0">
                  <c:v>Prevotell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G$2:$G$5</c:f>
              <c:numCache>
                <c:formatCode>0.00</c:formatCode>
                <c:ptCount val="4"/>
                <c:pt idx="0">
                  <c:v>11.005374541843148</c:v>
                </c:pt>
                <c:pt idx="1">
                  <c:v>6.2848089445937676</c:v>
                </c:pt>
                <c:pt idx="2">
                  <c:v>8.29397289281283</c:v>
                </c:pt>
                <c:pt idx="3">
                  <c:v>3.3548847357870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8CA-4FCA-AD67-978CEB3758B8}"/>
            </c:ext>
          </c:extLst>
        </c:ser>
        <c:ser>
          <c:idx val="5"/>
          <c:order val="5"/>
          <c:tx>
            <c:strRef>
              <c:f>Sheet1!$H$1</c:f>
              <c:strCache>
                <c:ptCount val="1"/>
                <c:pt idx="0">
                  <c:v>Alistipe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H$2:$H$5</c:f>
              <c:numCache>
                <c:formatCode>0.00</c:formatCode>
                <c:ptCount val="4"/>
                <c:pt idx="0">
                  <c:v>1.8086123193020196</c:v>
                </c:pt>
                <c:pt idx="1">
                  <c:v>1.0162695931888051</c:v>
                </c:pt>
                <c:pt idx="2">
                  <c:v>0.61706895866678513</c:v>
                </c:pt>
                <c:pt idx="3">
                  <c:v>1.09589628647322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8CA-4FCA-AD67-978CEB3758B8}"/>
            </c:ext>
          </c:extLst>
        </c:ser>
        <c:ser>
          <c:idx val="6"/>
          <c:order val="6"/>
          <c:tx>
            <c:strRef>
              <c:f>Sheet1!$I$1</c:f>
              <c:strCache>
                <c:ptCount val="1"/>
                <c:pt idx="0">
                  <c:v>Parabacteroides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I$2:$I$5</c:f>
              <c:numCache>
                <c:formatCode>0.00</c:formatCode>
                <c:ptCount val="4"/>
                <c:pt idx="0">
                  <c:v>3.583560310733521</c:v>
                </c:pt>
                <c:pt idx="1">
                  <c:v>3.8387244142032961</c:v>
                </c:pt>
                <c:pt idx="2">
                  <c:v>1.6064170310137609</c:v>
                </c:pt>
                <c:pt idx="3">
                  <c:v>1.5612738421422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8CA-4FCA-AD67-978CEB3758B8}"/>
            </c:ext>
          </c:extLst>
        </c:ser>
        <c:ser>
          <c:idx val="7"/>
          <c:order val="7"/>
          <c:tx>
            <c:strRef>
              <c:f>Sheet1!$J$1</c:f>
              <c:strCache>
                <c:ptCount val="1"/>
                <c:pt idx="0">
                  <c:v>Lachnospiraceae;__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J$2:$J$5</c:f>
              <c:numCache>
                <c:formatCode>0.00</c:formatCode>
                <c:ptCount val="4"/>
                <c:pt idx="0">
                  <c:v>4.1861105411753572</c:v>
                </c:pt>
                <c:pt idx="1">
                  <c:v>3.1401833150672953</c:v>
                </c:pt>
                <c:pt idx="2">
                  <c:v>6.2282977296652273</c:v>
                </c:pt>
                <c:pt idx="3">
                  <c:v>6.42187046369926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8CA-4FCA-AD67-978CEB3758B8}"/>
            </c:ext>
          </c:extLst>
        </c:ser>
        <c:ser>
          <c:idx val="8"/>
          <c:order val="8"/>
          <c:tx>
            <c:strRef>
              <c:f>Sheet1!$K$1</c:f>
              <c:strCache>
                <c:ptCount val="1"/>
                <c:pt idx="0">
                  <c:v>Agathobacter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K$2:$K$5</c:f>
              <c:numCache>
                <c:formatCode>0.00</c:formatCode>
                <c:ptCount val="4"/>
                <c:pt idx="0">
                  <c:v>1.19602340050297</c:v>
                </c:pt>
                <c:pt idx="1">
                  <c:v>0.77449506125576562</c:v>
                </c:pt>
                <c:pt idx="2">
                  <c:v>1.2103441993448181</c:v>
                </c:pt>
                <c:pt idx="3">
                  <c:v>2.43965492801912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8CA-4FCA-AD67-978CEB3758B8}"/>
            </c:ext>
          </c:extLst>
        </c:ser>
        <c:ser>
          <c:idx val="9"/>
          <c:order val="9"/>
          <c:tx>
            <c:strRef>
              <c:f>Sheet1!$L$1</c:f>
              <c:strCache>
                <c:ptCount val="1"/>
                <c:pt idx="0">
                  <c:v>Anaerostipe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L$2:$L$5</c:f>
              <c:numCache>
                <c:formatCode>0.00</c:formatCode>
                <c:ptCount val="4"/>
                <c:pt idx="0">
                  <c:v>0.32798534201432633</c:v>
                </c:pt>
                <c:pt idx="1">
                  <c:v>0.48583604575714101</c:v>
                </c:pt>
                <c:pt idx="2">
                  <c:v>3.0448747625736217</c:v>
                </c:pt>
                <c:pt idx="3">
                  <c:v>4.73496699046754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8CA-4FCA-AD67-978CEB3758B8}"/>
            </c:ext>
          </c:extLst>
        </c:ser>
        <c:ser>
          <c:idx val="10"/>
          <c:order val="10"/>
          <c:tx>
            <c:strRef>
              <c:f>Sheet1!$M$1</c:f>
              <c:strCache>
                <c:ptCount val="1"/>
                <c:pt idx="0">
                  <c:v>Blauti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M$2:$M$5</c:f>
              <c:numCache>
                <c:formatCode>0.00</c:formatCode>
                <c:ptCount val="4"/>
                <c:pt idx="0">
                  <c:v>2.1434493746628389</c:v>
                </c:pt>
                <c:pt idx="1">
                  <c:v>2.0678302531642196</c:v>
                </c:pt>
                <c:pt idx="2">
                  <c:v>11.593101095177806</c:v>
                </c:pt>
                <c:pt idx="3">
                  <c:v>11.2676062444586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F8CA-4FCA-AD67-978CEB3758B8}"/>
            </c:ext>
          </c:extLst>
        </c:ser>
        <c:ser>
          <c:idx val="11"/>
          <c:order val="11"/>
          <c:tx>
            <c:strRef>
              <c:f>Sheet1!$N$1</c:f>
              <c:strCache>
                <c:ptCount val="1"/>
                <c:pt idx="0">
                  <c:v>Lachnoclostridium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N$2:$N$5</c:f>
              <c:numCache>
                <c:formatCode>0.00</c:formatCode>
                <c:ptCount val="4"/>
                <c:pt idx="0">
                  <c:v>0.8016901570537327</c:v>
                </c:pt>
                <c:pt idx="1">
                  <c:v>1.3671435327853607</c:v>
                </c:pt>
                <c:pt idx="2">
                  <c:v>1.1797581457042761</c:v>
                </c:pt>
                <c:pt idx="3">
                  <c:v>1.28127187939639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F8CA-4FCA-AD67-978CEB3758B8}"/>
            </c:ext>
          </c:extLst>
        </c:ser>
        <c:ser>
          <c:idx val="12"/>
          <c:order val="12"/>
          <c:tx>
            <c:strRef>
              <c:f>Sheet1!$O$1</c:f>
              <c:strCache>
                <c:ptCount val="1"/>
                <c:pt idx="0">
                  <c:v>Roseburia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O$2:$O$5</c:f>
              <c:numCache>
                <c:formatCode>0.00</c:formatCode>
                <c:ptCount val="4"/>
                <c:pt idx="0">
                  <c:v>0.80383182842942058</c:v>
                </c:pt>
                <c:pt idx="1">
                  <c:v>0.90679614716783585</c:v>
                </c:pt>
                <c:pt idx="2">
                  <c:v>1.1808412999423361</c:v>
                </c:pt>
                <c:pt idx="3">
                  <c:v>1.0555596571099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8CA-4FCA-AD67-978CEB3758B8}"/>
            </c:ext>
          </c:extLst>
        </c:ser>
        <c:ser>
          <c:idx val="13"/>
          <c:order val="13"/>
          <c:tx>
            <c:strRef>
              <c:f>Sheet1!$P$1</c:f>
              <c:strCache>
                <c:ptCount val="1"/>
                <c:pt idx="0">
                  <c:v>[Eubacterium]_ruminantium_group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P$2:$P$5</c:f>
              <c:numCache>
                <c:formatCode>0.00</c:formatCode>
                <c:ptCount val="4"/>
                <c:pt idx="0">
                  <c:v>0.7882297500558032</c:v>
                </c:pt>
                <c:pt idx="1">
                  <c:v>0.206448495607362</c:v>
                </c:pt>
                <c:pt idx="2">
                  <c:v>2.3381520962296261</c:v>
                </c:pt>
                <c:pt idx="3">
                  <c:v>1.54251200234183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F8CA-4FCA-AD67-978CEB3758B8}"/>
            </c:ext>
          </c:extLst>
        </c:ser>
        <c:ser>
          <c:idx val="14"/>
          <c:order val="14"/>
          <c:tx>
            <c:strRef>
              <c:f>Sheet1!$Q$1</c:f>
              <c:strCache>
                <c:ptCount val="1"/>
                <c:pt idx="0">
                  <c:v>[Ruminococcus]_gnavus_group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Q$2:$Q$5</c:f>
              <c:numCache>
                <c:formatCode>0.00</c:formatCode>
                <c:ptCount val="4"/>
                <c:pt idx="0">
                  <c:v>0.53650628168000425</c:v>
                </c:pt>
                <c:pt idx="1">
                  <c:v>0.74224759473589386</c:v>
                </c:pt>
                <c:pt idx="2">
                  <c:v>0.87410421816873529</c:v>
                </c:pt>
                <c:pt idx="3">
                  <c:v>1.74677325861260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F8CA-4FCA-AD67-978CEB3758B8}"/>
            </c:ext>
          </c:extLst>
        </c:ser>
        <c:ser>
          <c:idx val="15"/>
          <c:order val="15"/>
          <c:tx>
            <c:strRef>
              <c:f>Sheet1!$R$1</c:f>
              <c:strCache>
                <c:ptCount val="1"/>
                <c:pt idx="0">
                  <c:v>[Ruminococcus]_torques_group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R$2:$R$5</c:f>
              <c:numCache>
                <c:formatCode>0.00</c:formatCode>
                <c:ptCount val="4"/>
                <c:pt idx="0">
                  <c:v>0.44712796623921475</c:v>
                </c:pt>
                <c:pt idx="1">
                  <c:v>0.55969892818873168</c:v>
                </c:pt>
                <c:pt idx="2">
                  <c:v>0.97511394040555222</c:v>
                </c:pt>
                <c:pt idx="3">
                  <c:v>1.7918321494309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F8CA-4FCA-AD67-978CEB3758B8}"/>
            </c:ext>
          </c:extLst>
        </c:ser>
        <c:ser>
          <c:idx val="16"/>
          <c:order val="16"/>
          <c:tx>
            <c:strRef>
              <c:f>Sheet1!$S$1</c:f>
              <c:strCache>
                <c:ptCount val="1"/>
                <c:pt idx="0">
                  <c:v>UCG-002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S$2:$S$5</c:f>
              <c:numCache>
                <c:formatCode>0.00</c:formatCode>
                <c:ptCount val="4"/>
                <c:pt idx="0">
                  <c:v>1.1379324344972093</c:v>
                </c:pt>
                <c:pt idx="1">
                  <c:v>0.59045716256288516</c:v>
                </c:pt>
                <c:pt idx="2">
                  <c:v>0.52498202434136787</c:v>
                </c:pt>
                <c:pt idx="3">
                  <c:v>0.492030209865157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F8CA-4FCA-AD67-978CEB3758B8}"/>
            </c:ext>
          </c:extLst>
        </c:ser>
        <c:ser>
          <c:idx val="17"/>
          <c:order val="17"/>
          <c:tx>
            <c:strRef>
              <c:f>Sheet1!$T$1</c:f>
              <c:strCache>
                <c:ptCount val="1"/>
                <c:pt idx="0">
                  <c:v>Faecalibacterium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T$2:$T$5</c:f>
              <c:numCache>
                <c:formatCode>0.00</c:formatCode>
                <c:ptCount val="4"/>
                <c:pt idx="0">
                  <c:v>3.5247874222892865</c:v>
                </c:pt>
                <c:pt idx="1">
                  <c:v>5.9396164676362968</c:v>
                </c:pt>
                <c:pt idx="2">
                  <c:v>5.7143408847231161</c:v>
                </c:pt>
                <c:pt idx="3">
                  <c:v>8.16468085385353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F8CA-4FCA-AD67-978CEB3758B8}"/>
            </c:ext>
          </c:extLst>
        </c:ser>
        <c:ser>
          <c:idx val="18"/>
          <c:order val="18"/>
          <c:tx>
            <c:strRef>
              <c:f>Sheet1!$U$1</c:f>
              <c:strCache>
                <c:ptCount val="1"/>
                <c:pt idx="0">
                  <c:v>Ruminococcus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U$2:$U$5</c:f>
              <c:numCache>
                <c:formatCode>0.00</c:formatCode>
                <c:ptCount val="4"/>
                <c:pt idx="0">
                  <c:v>1.1552275673349275</c:v>
                </c:pt>
                <c:pt idx="1">
                  <c:v>1.2616443548255358</c:v>
                </c:pt>
                <c:pt idx="2">
                  <c:v>3.7429840956041445</c:v>
                </c:pt>
                <c:pt idx="3">
                  <c:v>1.95437084738688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F8CA-4FCA-AD67-978CEB3758B8}"/>
            </c:ext>
          </c:extLst>
        </c:ser>
        <c:ser>
          <c:idx val="19"/>
          <c:order val="19"/>
          <c:tx>
            <c:strRef>
              <c:f>Sheet1!$V$1</c:f>
              <c:strCache>
                <c:ptCount val="1"/>
                <c:pt idx="0">
                  <c:v>[Eubacterium]_coprostanoligenes_group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V$2:$V$5</c:f>
              <c:numCache>
                <c:formatCode>0.00</c:formatCode>
                <c:ptCount val="4"/>
                <c:pt idx="0">
                  <c:v>1.2584068544156028</c:v>
                </c:pt>
                <c:pt idx="1">
                  <c:v>0.43937079549445474</c:v>
                </c:pt>
                <c:pt idx="2">
                  <c:v>3.1174967760668926</c:v>
                </c:pt>
                <c:pt idx="3">
                  <c:v>2.86168224174301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F8CA-4FCA-AD67-978CEB3758B8}"/>
            </c:ext>
          </c:extLst>
        </c:ser>
        <c:ser>
          <c:idx val="20"/>
          <c:order val="20"/>
          <c:tx>
            <c:strRef>
              <c:f>Sheet1!$W$1</c:f>
              <c:strCache>
                <c:ptCount val="1"/>
                <c:pt idx="0">
                  <c:v>Sutterella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W$2:$W$5</c:f>
              <c:numCache>
                <c:formatCode>0.00</c:formatCode>
                <c:ptCount val="4"/>
                <c:pt idx="0">
                  <c:v>2.5240260763928219</c:v>
                </c:pt>
                <c:pt idx="1">
                  <c:v>2.7560023346776554</c:v>
                </c:pt>
                <c:pt idx="2">
                  <c:v>0.79136166151685039</c:v>
                </c:pt>
                <c:pt idx="3">
                  <c:v>0.696883109253093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F8CA-4FCA-AD67-978CEB3758B8}"/>
            </c:ext>
          </c:extLst>
        </c:ser>
        <c:ser>
          <c:idx val="21"/>
          <c:order val="21"/>
          <c:tx>
            <c:strRef>
              <c:f>Sheet1!$X$1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Sheet1!$A$2:$B$5</c:f>
              <c:multiLvlStrCache>
                <c:ptCount val="4"/>
                <c:lvl>
                  <c:pt idx="0">
                    <c:v>Placebo</c:v>
                  </c:pt>
                  <c:pt idx="1">
                    <c:v>Kombu</c:v>
                  </c:pt>
                  <c:pt idx="2">
                    <c:v>Placebo</c:v>
                  </c:pt>
                  <c:pt idx="3">
                    <c:v>Kombu</c:v>
                  </c:pt>
                </c:lvl>
                <c:lvl>
                  <c:pt idx="0">
                    <c:v>Baseline</c:v>
                  </c:pt>
                  <c:pt idx="2">
                    <c:v>12W</c:v>
                  </c:pt>
                </c:lvl>
              </c:multiLvlStrCache>
            </c:multiLvlStrRef>
          </c:cat>
          <c:val>
            <c:numRef>
              <c:f>Sheet1!$X$2:$X$5</c:f>
              <c:numCache>
                <c:formatCode>0.00</c:formatCode>
                <c:ptCount val="4"/>
                <c:pt idx="0">
                  <c:v>28.728685227104123</c:v>
                </c:pt>
                <c:pt idx="1">
                  <c:v>25.679351078840099</c:v>
                </c:pt>
                <c:pt idx="2">
                  <c:v>23.520556153847664</c:v>
                </c:pt>
                <c:pt idx="3">
                  <c:v>19.402289841397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F8CA-4FCA-AD67-978CEB3758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69124207"/>
        <c:axId val="869141007"/>
      </c:barChart>
      <c:catAx>
        <c:axId val="8691242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69141007"/>
        <c:crosses val="autoZero"/>
        <c:auto val="1"/>
        <c:lblAlgn val="ctr"/>
        <c:lblOffset val="100"/>
        <c:noMultiLvlLbl val="0"/>
      </c:catAx>
      <c:valAx>
        <c:axId val="8691410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9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undanse</a:t>
                </a:r>
                <a:endParaRPr lang="ja-JP" altLang="en-US" sz="9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 alt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69124207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短鎖脂肪酸!$B$1</c:f>
              <c:strCache>
                <c:ptCount val="1"/>
                <c:pt idx="0">
                  <c:v>Acetat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6DE-4711-86D6-15762E2B4E2F}"/>
              </c:ext>
            </c:extLst>
          </c:dPt>
          <c:dPt>
            <c:idx val="1"/>
            <c:invertIfNegative val="0"/>
            <c:bubble3D val="0"/>
            <c:spPr>
              <a:solidFill>
                <a:srgbClr val="0432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6DE-4711-86D6-15762E2B4E2F}"/>
              </c:ext>
            </c:extLst>
          </c:dPt>
          <c:errBars>
            <c:errBarType val="plus"/>
            <c:errValType val="cust"/>
            <c:noEndCap val="0"/>
            <c:plus>
              <c:numRef>
                <c:f>短鎖脂肪酸!$H$2:$H$3</c:f>
                <c:numCache>
                  <c:formatCode>General</c:formatCode>
                  <c:ptCount val="2"/>
                  <c:pt idx="0">
                    <c:v>0.23</c:v>
                  </c:pt>
                  <c:pt idx="1">
                    <c:v>0.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短鎖脂肪酸!$A$2:$A$3</c:f>
              <c:strCache>
                <c:ptCount val="2"/>
                <c:pt idx="0">
                  <c:v>Placebo</c:v>
                </c:pt>
                <c:pt idx="1">
                  <c:v>Kombu</c:v>
                </c:pt>
              </c:strCache>
            </c:strRef>
          </c:cat>
          <c:val>
            <c:numRef>
              <c:f>短鎖脂肪酸!$B$2:$B$3</c:f>
              <c:numCache>
                <c:formatCode>General</c:formatCode>
                <c:ptCount val="2"/>
                <c:pt idx="0">
                  <c:v>1.99</c:v>
                </c:pt>
                <c:pt idx="1">
                  <c:v>1.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6DE-4711-86D6-15762E2B4E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470688"/>
        <c:axId val="1116054384"/>
      </c:barChart>
      <c:catAx>
        <c:axId val="156470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116054384"/>
        <c:crosses val="autoZero"/>
        <c:auto val="1"/>
        <c:lblAlgn val="ctr"/>
        <c:lblOffset val="100"/>
        <c:noMultiLvlLbl val="0"/>
      </c:catAx>
      <c:valAx>
        <c:axId val="111605438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05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g/g</a:t>
                </a:r>
                <a:endParaRPr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 alt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647068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短鎖脂肪酸!$C$1</c:f>
              <c:strCache>
                <c:ptCount val="1"/>
                <c:pt idx="0">
                  <c:v>Propionat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24B-42EB-ABA8-5AB326D5384A}"/>
              </c:ext>
            </c:extLst>
          </c:dPt>
          <c:dPt>
            <c:idx val="1"/>
            <c:invertIfNegative val="0"/>
            <c:bubble3D val="0"/>
            <c:spPr>
              <a:solidFill>
                <a:srgbClr val="0432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24B-42EB-ABA8-5AB326D5384A}"/>
              </c:ext>
            </c:extLst>
          </c:dPt>
          <c:errBars>
            <c:errBarType val="plus"/>
            <c:errValType val="cust"/>
            <c:noEndCap val="0"/>
            <c:plus>
              <c:numRef>
                <c:f>短鎖脂肪酸!$I$2:$I$3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短鎖脂肪酸!$A$2:$A$3</c:f>
              <c:strCache>
                <c:ptCount val="2"/>
                <c:pt idx="0">
                  <c:v>Placebo</c:v>
                </c:pt>
                <c:pt idx="1">
                  <c:v>Kombu</c:v>
                </c:pt>
              </c:strCache>
            </c:strRef>
          </c:cat>
          <c:val>
            <c:numRef>
              <c:f>短鎖脂肪酸!$C$2:$C$3</c:f>
              <c:numCache>
                <c:formatCode>General</c:formatCode>
                <c:ptCount val="2"/>
                <c:pt idx="0">
                  <c:v>0.93</c:v>
                </c:pt>
                <c:pt idx="1">
                  <c:v>0.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24B-42EB-ABA8-5AB326D538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12441600"/>
        <c:axId val="173904720"/>
      </c:barChart>
      <c:catAx>
        <c:axId val="1112441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3904720"/>
        <c:crosses val="autoZero"/>
        <c:auto val="1"/>
        <c:lblAlgn val="ctr"/>
        <c:lblOffset val="100"/>
        <c:noMultiLvlLbl val="0"/>
      </c:catAx>
      <c:valAx>
        <c:axId val="17390472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05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g/g</a:t>
                </a:r>
                <a:endParaRPr lang="ja-JP" altLang="en-US" sz="105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 alt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11244160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n-Butyrat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短鎖脂肪酸!$D$1</c:f>
              <c:strCache>
                <c:ptCount val="1"/>
                <c:pt idx="0">
                  <c:v>n-butyrat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E5F-4352-ADDF-9A6B5071EC47}"/>
              </c:ext>
            </c:extLst>
          </c:dPt>
          <c:dPt>
            <c:idx val="1"/>
            <c:invertIfNegative val="0"/>
            <c:bubble3D val="0"/>
            <c:spPr>
              <a:solidFill>
                <a:srgbClr val="0432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E5F-4352-ADDF-9A6B5071EC47}"/>
              </c:ext>
            </c:extLst>
          </c:dPt>
          <c:errBars>
            <c:errBarType val="plus"/>
            <c:errValType val="cust"/>
            <c:noEndCap val="0"/>
            <c:plus>
              <c:numRef>
                <c:f>短鎖脂肪酸!$J$2:$J$3</c:f>
                <c:numCache>
                  <c:formatCode>General</c:formatCode>
                  <c:ptCount val="2"/>
                  <c:pt idx="0">
                    <c:v>0.11</c:v>
                  </c:pt>
                  <c:pt idx="1">
                    <c:v>0.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短鎖脂肪酸!$A$2:$A$3</c:f>
              <c:strCache>
                <c:ptCount val="2"/>
                <c:pt idx="0">
                  <c:v>Placebo</c:v>
                </c:pt>
                <c:pt idx="1">
                  <c:v>Kombu</c:v>
                </c:pt>
              </c:strCache>
            </c:strRef>
          </c:cat>
          <c:val>
            <c:numRef>
              <c:f>短鎖脂肪酸!$D$2:$D$3</c:f>
              <c:numCache>
                <c:formatCode>General</c:formatCode>
                <c:ptCount val="2"/>
                <c:pt idx="0">
                  <c:v>0.7</c:v>
                </c:pt>
                <c:pt idx="1">
                  <c:v>0.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E5F-4352-ADDF-9A6B5071EC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478368"/>
        <c:axId val="156472608"/>
      </c:barChart>
      <c:catAx>
        <c:axId val="156478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6472608"/>
        <c:crosses val="autoZero"/>
        <c:auto val="1"/>
        <c:lblAlgn val="ctr"/>
        <c:lblOffset val="100"/>
        <c:noMultiLvlLbl val="0"/>
      </c:catAx>
      <c:valAx>
        <c:axId val="15647260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05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g/g</a:t>
                </a:r>
                <a:endParaRPr lang="ja-JP" altLang="en-US" sz="105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 alt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6478368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短鎖脂肪酸!$E$1</c:f>
              <c:strCache>
                <c:ptCount val="1"/>
                <c:pt idx="0">
                  <c:v>Total SCF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F8B-46F2-A197-D86AAC4A9B80}"/>
              </c:ext>
            </c:extLst>
          </c:dPt>
          <c:dPt>
            <c:idx val="1"/>
            <c:invertIfNegative val="0"/>
            <c:bubble3D val="0"/>
            <c:spPr>
              <a:solidFill>
                <a:srgbClr val="0432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F8B-46F2-A197-D86AAC4A9B80}"/>
              </c:ext>
            </c:extLst>
          </c:dPt>
          <c:errBars>
            <c:errBarType val="plus"/>
            <c:errValType val="cust"/>
            <c:noEndCap val="0"/>
            <c:plus>
              <c:numRef>
                <c:f>短鎖脂肪酸!$F$2:$F$3</c:f>
                <c:numCache>
                  <c:formatCode>General</c:formatCode>
                  <c:ptCount val="2"/>
                  <c:pt idx="0">
                    <c:v>0.42</c:v>
                  </c:pt>
                  <c:pt idx="1">
                    <c:v>0.3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短鎖脂肪酸!$A$2:$A$3</c:f>
              <c:strCache>
                <c:ptCount val="2"/>
                <c:pt idx="0">
                  <c:v>Placebo</c:v>
                </c:pt>
                <c:pt idx="1">
                  <c:v>Kombu</c:v>
                </c:pt>
              </c:strCache>
            </c:strRef>
          </c:cat>
          <c:val>
            <c:numRef>
              <c:f>短鎖脂肪酸!$E$2:$E$3</c:f>
              <c:numCache>
                <c:formatCode>General</c:formatCode>
                <c:ptCount val="2"/>
                <c:pt idx="0">
                  <c:v>3.94</c:v>
                </c:pt>
                <c:pt idx="1">
                  <c:v>3.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F8B-46F2-A197-D86AAC4A9B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475008"/>
        <c:axId val="156468288"/>
      </c:barChart>
      <c:catAx>
        <c:axId val="156475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6468288"/>
        <c:crosses val="autoZero"/>
        <c:auto val="1"/>
        <c:lblAlgn val="ctr"/>
        <c:lblOffset val="100"/>
        <c:noMultiLvlLbl val="0"/>
      </c:catAx>
      <c:valAx>
        <c:axId val="15646828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ja-JP" sz="105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g/g</a:t>
                </a:r>
                <a:endParaRPr lang="ja-JP" altLang="en-US" sz="105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 alt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56475008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0542D6-8190-46C2-847A-9B99EBA728D8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889EF7-174D-470B-B4C9-DC5684AFE3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3073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889EF7-174D-470B-B4C9-DC5684AFE3E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8061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426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144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18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8151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826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5509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7579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135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940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4906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4712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311F94-1650-46AD-924C-44AE2064EAA6}" type="datetimeFigureOut">
              <a:rPr kumimoji="1" lang="ja-JP" altLang="en-US" smtClean="0"/>
              <a:t>2025/5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7F2053-1C7E-4489-BD41-8CE5305AC5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904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B5EACCF-EFF3-5F51-7D7B-F1BF43D9EEDC}"/>
              </a:ext>
            </a:extLst>
          </p:cNvPr>
          <p:cNvSpPr txBox="1"/>
          <p:nvPr/>
        </p:nvSpPr>
        <p:spPr>
          <a:xfrm>
            <a:off x="1951933" y="6121696"/>
            <a:ext cx="5463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1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arance of the test cookies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808384CF-349D-0DCB-0C14-C978BA29E6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887" y="1314450"/>
            <a:ext cx="7896225" cy="42291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896B962-7C30-9884-F56A-41F6ECA69FD6}"/>
              </a:ext>
            </a:extLst>
          </p:cNvPr>
          <p:cNvSpPr txBox="1"/>
          <p:nvPr/>
        </p:nvSpPr>
        <p:spPr>
          <a:xfrm>
            <a:off x="2315982" y="5525120"/>
            <a:ext cx="1371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cebo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410820A-49B3-46AB-EEA7-0D37E9DB0FF7}"/>
              </a:ext>
            </a:extLst>
          </p:cNvPr>
          <p:cNvSpPr txBox="1"/>
          <p:nvPr/>
        </p:nvSpPr>
        <p:spPr>
          <a:xfrm>
            <a:off x="5916120" y="5525119"/>
            <a:ext cx="1371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mbu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9150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28597FEF-CE78-8071-6B42-8A0A1B102C0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2035386"/>
              </p:ext>
            </p:extLst>
          </p:nvPr>
        </p:nvGraphicFramePr>
        <p:xfrm>
          <a:off x="0" y="1"/>
          <a:ext cx="4112485" cy="43385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86E55CA-6FB8-2304-A9B5-C724FFF85673}"/>
              </a:ext>
            </a:extLst>
          </p:cNvPr>
          <p:cNvSpPr txBox="1"/>
          <p:nvPr/>
        </p:nvSpPr>
        <p:spPr>
          <a:xfrm>
            <a:off x="719527" y="6058771"/>
            <a:ext cx="801973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2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verage relative abundances of detected bacteria phylum and genera in stool samples obtained at baseline and week 12.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A798C2EB-803D-3196-EDA7-11B5768304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822121"/>
              </p:ext>
            </p:extLst>
          </p:nvPr>
        </p:nvGraphicFramePr>
        <p:xfrm>
          <a:off x="3915061" y="33728"/>
          <a:ext cx="4975366" cy="59367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402036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A4310BE-106A-A9E5-5669-29F6955BBF2C}"/>
              </a:ext>
            </a:extLst>
          </p:cNvPr>
          <p:cNvSpPr txBox="1"/>
          <p:nvPr/>
        </p:nvSpPr>
        <p:spPr>
          <a:xfrm>
            <a:off x="1269944" y="6333664"/>
            <a:ext cx="73438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3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cal SCFA concentrations of subjects at week 12.</a:t>
            </a:r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D534AD4C-4BA7-4789-5875-010728B453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0487478"/>
              </p:ext>
            </p:extLst>
          </p:nvPr>
        </p:nvGraphicFramePr>
        <p:xfrm>
          <a:off x="263526" y="598422"/>
          <a:ext cx="4305300" cy="2813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D5FFA364-7E2B-CFD9-4033-D2E89278F3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3608412"/>
              </p:ext>
            </p:extLst>
          </p:nvPr>
        </p:nvGraphicFramePr>
        <p:xfrm>
          <a:off x="4532314" y="633479"/>
          <a:ext cx="4305300" cy="2813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786068D5-C204-51C4-28D8-4CBCE54861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3027817"/>
              </p:ext>
            </p:extLst>
          </p:nvPr>
        </p:nvGraphicFramePr>
        <p:xfrm>
          <a:off x="284957" y="3357299"/>
          <a:ext cx="4305300" cy="2813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8F09AAB2-58EC-6053-287D-76490156AA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1958540"/>
              </p:ext>
            </p:extLst>
          </p:nvPr>
        </p:nvGraphicFramePr>
        <p:xfrm>
          <a:off x="4611688" y="3446529"/>
          <a:ext cx="4305300" cy="2813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497905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70</Words>
  <Application>Microsoft Office PowerPoint</Application>
  <PresentationFormat>画面に合わせる (4:3)</PresentationFormat>
  <Paragraphs>18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Aptos</vt:lpstr>
      <vt:lpstr>Aptos Display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青江誠一郎</dc:creator>
  <cp:lastModifiedBy>青江　誠一郎</cp:lastModifiedBy>
  <cp:revision>3</cp:revision>
  <dcterms:created xsi:type="dcterms:W3CDTF">2024-12-16T01:56:29Z</dcterms:created>
  <dcterms:modified xsi:type="dcterms:W3CDTF">2025-05-08T13:42:22Z</dcterms:modified>
</cp:coreProperties>
</file>